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13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 MANSO" userId="073468f2-32c1-4a1d-b0d5-be6d95ac509e" providerId="ADAL" clId="{BB374721-E2E3-4D10-BF55-A77462EE22F0}"/>
    <pc:docChg chg="undo custSel modSld">
      <pc:chgData name="Maria MANSO" userId="073468f2-32c1-4a1d-b0d5-be6d95ac509e" providerId="ADAL" clId="{BB374721-E2E3-4D10-BF55-A77462EE22F0}" dt="2020-07-02T12:15:58.358" v="36" actId="20577"/>
      <pc:docMkLst>
        <pc:docMk/>
      </pc:docMkLst>
      <pc:sldChg chg="addSp modSp mod">
        <pc:chgData name="Maria MANSO" userId="073468f2-32c1-4a1d-b0d5-be6d95ac509e" providerId="ADAL" clId="{BB374721-E2E3-4D10-BF55-A77462EE22F0}" dt="2020-07-02T12:15:58.358" v="36" actId="20577"/>
        <pc:sldMkLst>
          <pc:docMk/>
          <pc:sldMk cId="2867428870" sldId="268"/>
        </pc:sldMkLst>
        <pc:spChg chg="mod">
          <ac:chgData name="Maria MANSO" userId="073468f2-32c1-4a1d-b0d5-be6d95ac509e" providerId="ADAL" clId="{BB374721-E2E3-4D10-BF55-A77462EE22F0}" dt="2020-07-02T12:15:52.809" v="32" actId="20577"/>
          <ac:spMkLst>
            <pc:docMk/>
            <pc:sldMk cId="2867428870" sldId="268"/>
            <ac:spMk id="20" creationId="{E9320D41-D805-4110-92F1-CB2C46BAF657}"/>
          </ac:spMkLst>
        </pc:spChg>
        <pc:spChg chg="mod">
          <ac:chgData name="Maria MANSO" userId="073468f2-32c1-4a1d-b0d5-be6d95ac509e" providerId="ADAL" clId="{BB374721-E2E3-4D10-BF55-A77462EE22F0}" dt="2020-07-02T12:15:55.399" v="34" actId="20577"/>
          <ac:spMkLst>
            <pc:docMk/>
            <pc:sldMk cId="2867428870" sldId="268"/>
            <ac:spMk id="21" creationId="{3FF11B82-D65C-47A0-82EF-528241D5C1D6}"/>
          </ac:spMkLst>
        </pc:spChg>
        <pc:spChg chg="mod">
          <ac:chgData name="Maria MANSO" userId="073468f2-32c1-4a1d-b0d5-be6d95ac509e" providerId="ADAL" clId="{BB374721-E2E3-4D10-BF55-A77462EE22F0}" dt="2020-07-02T12:15:48.162" v="28" actId="20577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Maria MANSO" userId="073468f2-32c1-4a1d-b0d5-be6d95ac509e" providerId="ADAL" clId="{BB374721-E2E3-4D10-BF55-A77462EE22F0}" dt="2020-07-02T12:15:58.358" v="36" actId="20577"/>
          <ac:spMkLst>
            <pc:docMk/>
            <pc:sldMk cId="2867428870" sldId="268"/>
            <ac:spMk id="38" creationId="{7C1EE603-8A35-4CCB-A255-7FD568BCC9B0}"/>
          </ac:spMkLst>
        </pc:spChg>
        <pc:spChg chg="mod">
          <ac:chgData name="Maria MANSO" userId="073468f2-32c1-4a1d-b0d5-be6d95ac509e" providerId="ADAL" clId="{BB374721-E2E3-4D10-BF55-A77462EE22F0}" dt="2020-07-02T12:15:50.122" v="30" actId="20577"/>
          <ac:spMkLst>
            <pc:docMk/>
            <pc:sldMk cId="2867428870" sldId="268"/>
            <ac:spMk id="39" creationId="{E0F36511-64F5-43E9-9D7C-0A5B0CEE7DAF}"/>
          </ac:spMkLst>
        </pc:spChg>
        <pc:spChg chg="mod">
          <ac:chgData name="Maria MANSO" userId="073468f2-32c1-4a1d-b0d5-be6d95ac509e" providerId="ADAL" clId="{BB374721-E2E3-4D10-BF55-A77462EE22F0}" dt="2020-07-02T10:41:40.669" v="12" actId="1036"/>
          <ac:spMkLst>
            <pc:docMk/>
            <pc:sldMk cId="2867428870" sldId="268"/>
            <ac:spMk id="40" creationId="{887891F4-F189-48F2-A933-8FAC156FC674}"/>
          </ac:spMkLst>
        </pc:spChg>
        <pc:cxnChg chg="add mod">
          <ac:chgData name="Maria MANSO" userId="073468f2-32c1-4a1d-b0d5-be6d95ac509e" providerId="ADAL" clId="{BB374721-E2E3-4D10-BF55-A77462EE22F0}" dt="2020-07-02T10:42:08.325" v="16" actId="1036"/>
          <ac:cxnSpMkLst>
            <pc:docMk/>
            <pc:sldMk cId="2867428870" sldId="268"/>
            <ac:cxnSpMk id="4" creationId="{8BA08E3B-BC8A-45A2-9696-D23A4C2F8F5B}"/>
          </ac:cxnSpMkLst>
        </pc:cxnChg>
        <pc:cxnChg chg="add mod">
          <ac:chgData name="Maria MANSO" userId="073468f2-32c1-4a1d-b0d5-be6d95ac509e" providerId="ADAL" clId="{BB374721-E2E3-4D10-BF55-A77462EE22F0}" dt="2020-07-02T10:41:24.864" v="11" actId="14100"/>
          <ac:cxnSpMkLst>
            <pc:docMk/>
            <pc:sldMk cId="2867428870" sldId="268"/>
            <ac:cxnSpMk id="41" creationId="{9932D029-2B99-42AC-B68E-2CDE3A5DB6C8}"/>
          </ac:cxnSpMkLst>
        </pc:cxnChg>
      </pc:sldChg>
    </pc:docChg>
  </pc:docChgLst>
  <pc:docChgLst>
    <pc:chgData name="Maria MANSO" userId="073468f2-32c1-4a1d-b0d5-be6d95ac509e" providerId="ADAL" clId="{A1059A91-505C-4043-A98B-4B3E2780359B}"/>
    <pc:docChg chg="undo custSel modSld">
      <pc:chgData name="Maria MANSO" userId="073468f2-32c1-4a1d-b0d5-be6d95ac509e" providerId="ADAL" clId="{A1059A91-505C-4043-A98B-4B3E2780359B}" dt="2020-07-02T08:25:59.515" v="113" actId="20577"/>
      <pc:docMkLst>
        <pc:docMk/>
      </pc:docMkLst>
      <pc:sldChg chg="modSp mod">
        <pc:chgData name="Maria MANSO" userId="073468f2-32c1-4a1d-b0d5-be6d95ac509e" providerId="ADAL" clId="{A1059A91-505C-4043-A98B-4B3E2780359B}" dt="2020-07-02T08:25:59.515" v="113" actId="20577"/>
        <pc:sldMkLst>
          <pc:docMk/>
          <pc:sldMk cId="2867428870" sldId="268"/>
        </pc:sldMkLst>
        <pc:spChg chg="mod">
          <ac:chgData name="Maria MANSO" userId="073468f2-32c1-4a1d-b0d5-be6d95ac509e" providerId="ADAL" clId="{A1059A91-505C-4043-A98B-4B3E2780359B}" dt="2020-07-02T08:25:59.515" v="113" actId="20577"/>
          <ac:spMkLst>
            <pc:docMk/>
            <pc:sldMk cId="2867428870" sldId="268"/>
            <ac:spMk id="20" creationId="{E9320D41-D805-4110-92F1-CB2C46BAF657}"/>
          </ac:spMkLst>
        </pc:spChg>
        <pc:spChg chg="mod">
          <ac:chgData name="Maria MANSO" userId="073468f2-32c1-4a1d-b0d5-be6d95ac509e" providerId="ADAL" clId="{A1059A91-505C-4043-A98B-4B3E2780359B}" dt="2020-07-02T08:22:33.897" v="99" actId="20577"/>
          <ac:spMkLst>
            <pc:docMk/>
            <pc:sldMk cId="2867428870" sldId="268"/>
            <ac:spMk id="28" creationId="{00000000-0000-0000-0000-000000000000}"/>
          </ac:spMkLst>
        </pc:spChg>
        <pc:spChg chg="mod">
          <ac:chgData name="Maria MANSO" userId="073468f2-32c1-4a1d-b0d5-be6d95ac509e" providerId="ADAL" clId="{A1059A91-505C-4043-A98B-4B3E2780359B}" dt="2020-07-02T08:25:51.007" v="112" actId="20577"/>
          <ac:spMkLst>
            <pc:docMk/>
            <pc:sldMk cId="2867428870" sldId="268"/>
            <ac:spMk id="39" creationId="{E0F36511-64F5-43E9-9D7C-0A5B0CEE7DA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2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2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260541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700" b="1" dirty="0">
                <a:solidFill>
                  <a:schemeClr val="bg1"/>
                </a:solidFill>
              </a:rPr>
              <a:t>Efficacy and safety of an innovative prolonged-release combination drug in patients with distal renal tubular acidosis (</a:t>
            </a:r>
            <a:r>
              <a:rPr lang="en-US" sz="2700" b="1" dirty="0" err="1">
                <a:solidFill>
                  <a:schemeClr val="bg1"/>
                </a:solidFill>
              </a:rPr>
              <a:t>dRTA</a:t>
            </a:r>
            <a:r>
              <a:rPr lang="en-US" sz="2700" b="1" dirty="0">
                <a:solidFill>
                  <a:schemeClr val="bg1"/>
                </a:solidFill>
              </a:rPr>
              <a:t>): an open-label comparative trial versus standard of care (SoC) treatments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M</a:t>
            </a:r>
            <a:r>
              <a:rPr lang="en-US" dirty="0" err="1">
                <a:solidFill>
                  <a:schemeClr val="bg1"/>
                </a:solidFill>
              </a:rPr>
              <a:t>etabolic</a:t>
            </a:r>
            <a:r>
              <a:rPr lang="en-US" dirty="0">
                <a:solidFill>
                  <a:schemeClr val="bg1"/>
                </a:solidFill>
              </a:rPr>
              <a:t> control in patients with </a:t>
            </a:r>
            <a:r>
              <a:rPr lang="en-US" dirty="0" err="1">
                <a:solidFill>
                  <a:schemeClr val="bg1"/>
                </a:solidFill>
              </a:rPr>
              <a:t>dRTA</a:t>
            </a:r>
            <a:r>
              <a:rPr lang="en-US" dirty="0">
                <a:solidFill>
                  <a:schemeClr val="bg1"/>
                </a:solidFill>
              </a:rPr>
              <a:t> is </a:t>
            </a:r>
            <a:r>
              <a:rPr lang="en-GB" dirty="0">
                <a:solidFill>
                  <a:schemeClr val="bg1"/>
                </a:solidFill>
              </a:rPr>
              <a:t>improved </a:t>
            </a:r>
            <a:r>
              <a:rPr lang="en-US" dirty="0">
                <a:solidFill>
                  <a:schemeClr val="bg1"/>
                </a:solidFill>
              </a:rPr>
              <a:t>with ADV7103 when compared vs. SoC treatment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645733" y="2297328"/>
            <a:ext cx="54218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Plasma bicarbonate levels (superiority p = 0,0008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Bertholet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-Thomas et al. 2020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When switching from SoC to ADV7103, management of plasma bicarbonate levels and risk of stone formation, as well as palatability and gastrointestinal safety, were significantly improved</a:t>
            </a:r>
            <a:r>
              <a:rPr lang="en-GB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2D73F7E-F3FE-44DF-B755-FF0B0045A0BC}"/>
              </a:ext>
            </a:extLst>
          </p:cNvPr>
          <p:cNvSpPr/>
          <p:nvPr/>
        </p:nvSpPr>
        <p:spPr>
          <a:xfrm>
            <a:off x="332279" y="258275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40B60EDB-11D9-492C-892A-2A1DB8675C67}"/>
              </a:ext>
            </a:extLst>
          </p:cNvPr>
          <p:cNvSpPr/>
          <p:nvPr/>
        </p:nvSpPr>
        <p:spPr>
          <a:xfrm>
            <a:off x="565952" y="289715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55BC5E8B-EAFA-4B96-B6C1-E91405CF9BE8}"/>
              </a:ext>
            </a:extLst>
          </p:cNvPr>
          <p:cNvSpPr/>
          <p:nvPr/>
        </p:nvSpPr>
        <p:spPr>
          <a:xfrm>
            <a:off x="908338" y="258275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F49D4D18-BCF5-43D2-987F-E77AEAAF462F}"/>
              </a:ext>
            </a:extLst>
          </p:cNvPr>
          <p:cNvSpPr/>
          <p:nvPr/>
        </p:nvSpPr>
        <p:spPr>
          <a:xfrm>
            <a:off x="1079236" y="289715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1" name="TextBox 27">
            <a:extLst>
              <a:ext uri="{FF2B5EF4-FFF2-40B4-BE49-F238E27FC236}">
                <a16:creationId xmlns:a16="http://schemas.microsoft.com/office/drawing/2014/main" id="{A295ADC6-B445-4390-8610-15FFCBE91051}"/>
              </a:ext>
            </a:extLst>
          </p:cNvPr>
          <p:cNvSpPr txBox="1"/>
          <p:nvPr/>
        </p:nvSpPr>
        <p:spPr>
          <a:xfrm>
            <a:off x="107580" y="4010879"/>
            <a:ext cx="17385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err="1"/>
              <a:t>Pediatric</a:t>
            </a:r>
            <a:r>
              <a:rPr lang="en-GB" sz="2000" dirty="0"/>
              <a:t> and adult patients with </a:t>
            </a:r>
            <a:r>
              <a:rPr lang="en-GB" sz="2000" dirty="0" err="1"/>
              <a:t>dRTA</a:t>
            </a:r>
            <a:endParaRPr lang="en-GB" sz="2000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9337905-0082-4EF5-9170-2C26297A0C38}"/>
              </a:ext>
            </a:extLst>
          </p:cNvPr>
          <p:cNvSpPr/>
          <p:nvPr/>
        </p:nvSpPr>
        <p:spPr>
          <a:xfrm>
            <a:off x="2611903" y="1804718"/>
            <a:ext cx="1451783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SoC </a:t>
            </a:r>
          </a:p>
          <a:p>
            <a:pPr algn="ctr"/>
            <a:r>
              <a:rPr lang="en-GB" dirty="0"/>
              <a:t>(N=37)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E68A268-0D62-44C3-B42D-73CEBC63598A}"/>
              </a:ext>
            </a:extLst>
          </p:cNvPr>
          <p:cNvSpPr/>
          <p:nvPr/>
        </p:nvSpPr>
        <p:spPr>
          <a:xfrm>
            <a:off x="4366025" y="1804718"/>
            <a:ext cx="1451783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DV7103 (N=34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90B181E-8FEE-4525-89D4-8EF182C32629}"/>
              </a:ext>
            </a:extLst>
          </p:cNvPr>
          <p:cNvSpPr/>
          <p:nvPr/>
        </p:nvSpPr>
        <p:spPr>
          <a:xfrm>
            <a:off x="6645733" y="3196022"/>
            <a:ext cx="410803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dirty="0"/>
              <a:t>Plasma potassium levels </a:t>
            </a:r>
            <a:endParaRPr lang="fr-FR" sz="2000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9320D41-D805-4110-92F1-CB2C46BAF657}"/>
              </a:ext>
            </a:extLst>
          </p:cNvPr>
          <p:cNvSpPr/>
          <p:nvPr/>
        </p:nvSpPr>
        <p:spPr>
          <a:xfrm>
            <a:off x="6645733" y="3645369"/>
            <a:ext cx="504202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dirty="0"/>
              <a:t>R</a:t>
            </a:r>
            <a:r>
              <a:rPr lang="en-US" sz="2000" dirty="0" err="1"/>
              <a:t>isk</a:t>
            </a:r>
            <a:r>
              <a:rPr lang="en-US" sz="2000" dirty="0"/>
              <a:t> of stone formation (</a:t>
            </a:r>
            <a:r>
              <a:rPr lang="en-US" sz="2000" dirty="0" err="1"/>
              <a:t>McNemar’s</a:t>
            </a:r>
            <a:r>
              <a:rPr lang="en-US" sz="2000" dirty="0"/>
              <a:t> p = 0,021)</a:t>
            </a:r>
            <a:endParaRPr lang="fr-FR" sz="20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FF11B82-D65C-47A0-82EF-528241D5C1D6}"/>
              </a:ext>
            </a:extLst>
          </p:cNvPr>
          <p:cNvSpPr/>
          <p:nvPr/>
        </p:nvSpPr>
        <p:spPr>
          <a:xfrm>
            <a:off x="6645733" y="4094716"/>
            <a:ext cx="50420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dirty="0"/>
              <a:t>Palatability (d = 25 mm in VAS) </a:t>
            </a:r>
            <a:endParaRPr lang="fr-FR" sz="2000" dirty="0"/>
          </a:p>
        </p:txBody>
      </p:sp>
      <p:sp>
        <p:nvSpPr>
          <p:cNvPr id="30" name="Up Arrow 10">
            <a:extLst>
              <a:ext uri="{FF2B5EF4-FFF2-40B4-BE49-F238E27FC236}">
                <a16:creationId xmlns:a16="http://schemas.microsoft.com/office/drawing/2014/main" id="{FEDBA283-51F7-49D4-993E-DFED222A8FE5}"/>
              </a:ext>
            </a:extLst>
          </p:cNvPr>
          <p:cNvSpPr/>
          <p:nvPr/>
        </p:nvSpPr>
        <p:spPr>
          <a:xfrm>
            <a:off x="6315866" y="2334414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Up Arrow 10">
            <a:extLst>
              <a:ext uri="{FF2B5EF4-FFF2-40B4-BE49-F238E27FC236}">
                <a16:creationId xmlns:a16="http://schemas.microsoft.com/office/drawing/2014/main" id="{FC4BE30D-6FAC-488F-8319-914583242605}"/>
              </a:ext>
            </a:extLst>
          </p:cNvPr>
          <p:cNvSpPr/>
          <p:nvPr/>
        </p:nvSpPr>
        <p:spPr>
          <a:xfrm rot="5400000">
            <a:off x="6245803" y="3132403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DA9B888D-B6EE-4B2C-8B7F-D1AD4512C75F}"/>
              </a:ext>
            </a:extLst>
          </p:cNvPr>
          <p:cNvSpPr/>
          <p:nvPr/>
        </p:nvSpPr>
        <p:spPr>
          <a:xfrm>
            <a:off x="6645733" y="4544063"/>
            <a:ext cx="279339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/>
              <a:t>Number of daily intakes </a:t>
            </a:r>
            <a:endParaRPr lang="fr-FR" sz="2000" dirty="0"/>
          </a:p>
        </p:txBody>
      </p:sp>
      <p:sp>
        <p:nvSpPr>
          <p:cNvPr id="34" name="Up Arrow 12">
            <a:extLst>
              <a:ext uri="{FF2B5EF4-FFF2-40B4-BE49-F238E27FC236}">
                <a16:creationId xmlns:a16="http://schemas.microsoft.com/office/drawing/2014/main" id="{5134E669-9036-42C7-942B-D6FDEC42928F}"/>
              </a:ext>
            </a:extLst>
          </p:cNvPr>
          <p:cNvSpPr/>
          <p:nvPr/>
        </p:nvSpPr>
        <p:spPr>
          <a:xfrm rot="10800000">
            <a:off x="6309327" y="3501779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E14E78E-9863-4569-B8D3-774DD98E4A01}"/>
              </a:ext>
            </a:extLst>
          </p:cNvPr>
          <p:cNvSpPr/>
          <p:nvPr/>
        </p:nvSpPr>
        <p:spPr>
          <a:xfrm>
            <a:off x="7571932" y="1819282"/>
            <a:ext cx="318183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/>
              <a:t>Switch from SoC to ADV7103</a:t>
            </a:r>
            <a:endParaRPr lang="fr-FR" sz="2000" dirty="0"/>
          </a:p>
        </p:txBody>
      </p:sp>
      <p:sp>
        <p:nvSpPr>
          <p:cNvPr id="35" name="Up Arrow 10">
            <a:extLst>
              <a:ext uri="{FF2B5EF4-FFF2-40B4-BE49-F238E27FC236}">
                <a16:creationId xmlns:a16="http://schemas.microsoft.com/office/drawing/2014/main" id="{19A94A88-2885-45C4-9045-258247B5E2DB}"/>
              </a:ext>
            </a:extLst>
          </p:cNvPr>
          <p:cNvSpPr/>
          <p:nvPr/>
        </p:nvSpPr>
        <p:spPr>
          <a:xfrm>
            <a:off x="6315866" y="4132244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Up Arrow 12">
            <a:extLst>
              <a:ext uri="{FF2B5EF4-FFF2-40B4-BE49-F238E27FC236}">
                <a16:creationId xmlns:a16="http://schemas.microsoft.com/office/drawing/2014/main" id="{FFDA6A02-C9F6-400C-80D4-BAC96F29C7AA}"/>
              </a:ext>
            </a:extLst>
          </p:cNvPr>
          <p:cNvSpPr/>
          <p:nvPr/>
        </p:nvSpPr>
        <p:spPr>
          <a:xfrm rot="10800000">
            <a:off x="6306157" y="4407131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Up Arrow 12">
            <a:extLst>
              <a:ext uri="{FF2B5EF4-FFF2-40B4-BE49-F238E27FC236}">
                <a16:creationId xmlns:a16="http://schemas.microsoft.com/office/drawing/2014/main" id="{713A67B3-2B76-4D75-B27A-365F07A8A2CF}"/>
              </a:ext>
            </a:extLst>
          </p:cNvPr>
          <p:cNvSpPr/>
          <p:nvPr/>
        </p:nvSpPr>
        <p:spPr>
          <a:xfrm rot="10800000">
            <a:off x="6306432" y="483825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C1EE603-8A35-4CCB-A255-7FD568BCC9B0}"/>
              </a:ext>
            </a:extLst>
          </p:cNvPr>
          <p:cNvSpPr/>
          <p:nvPr/>
        </p:nvSpPr>
        <p:spPr>
          <a:xfrm>
            <a:off x="6628726" y="4993410"/>
            <a:ext cx="54388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dirty="0"/>
              <a:t>GI tolerability problems (d = -14,2 mm in VAS) </a:t>
            </a:r>
            <a:endParaRPr lang="fr-FR" sz="2000" dirty="0"/>
          </a:p>
        </p:txBody>
      </p:sp>
      <p:sp>
        <p:nvSpPr>
          <p:cNvPr id="39" name="TextBox 25">
            <a:extLst>
              <a:ext uri="{FF2B5EF4-FFF2-40B4-BE49-F238E27FC236}">
                <a16:creationId xmlns:a16="http://schemas.microsoft.com/office/drawing/2014/main" id="{E0F36511-64F5-43E9-9D7C-0A5B0CEE7DAF}"/>
              </a:ext>
            </a:extLst>
          </p:cNvPr>
          <p:cNvSpPr txBox="1"/>
          <p:nvPr/>
        </p:nvSpPr>
        <p:spPr>
          <a:xfrm>
            <a:off x="6645733" y="2746675"/>
            <a:ext cx="55462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Bicarbonate in normal range (</a:t>
            </a:r>
            <a:r>
              <a:rPr lang="en-US" sz="2000" dirty="0" err="1"/>
              <a:t>McNemar’s</a:t>
            </a:r>
            <a:r>
              <a:rPr lang="en-GB" sz="2000" dirty="0"/>
              <a:t> p &lt; 0,001)</a:t>
            </a:r>
          </a:p>
        </p:txBody>
      </p:sp>
      <p:sp>
        <p:nvSpPr>
          <p:cNvPr id="40" name="Up Arrow 10">
            <a:extLst>
              <a:ext uri="{FF2B5EF4-FFF2-40B4-BE49-F238E27FC236}">
                <a16:creationId xmlns:a16="http://schemas.microsoft.com/office/drawing/2014/main" id="{887891F4-F189-48F2-A933-8FAC156FC674}"/>
              </a:ext>
            </a:extLst>
          </p:cNvPr>
          <p:cNvSpPr/>
          <p:nvPr/>
        </p:nvSpPr>
        <p:spPr>
          <a:xfrm>
            <a:off x="6315866" y="2743450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8" name="Image 17">
            <a:extLst>
              <a:ext uri="{FF2B5EF4-FFF2-40B4-BE49-F238E27FC236}">
                <a16:creationId xmlns:a16="http://schemas.microsoft.com/office/drawing/2014/main" id="{B1543FD5-BC1E-4A44-A2CC-471F9FA0E9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1830" y="2489421"/>
            <a:ext cx="4137209" cy="2976521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0B77656B-BB4D-413C-A4D7-E73539F772EA}"/>
              </a:ext>
            </a:extLst>
          </p:cNvPr>
          <p:cNvSpPr/>
          <p:nvPr/>
        </p:nvSpPr>
        <p:spPr>
          <a:xfrm>
            <a:off x="180182" y="1745697"/>
            <a:ext cx="24048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endParaRPr lang="en-GB" dirty="0"/>
          </a:p>
        </p:txBody>
      </p:sp>
      <p:cxnSp>
        <p:nvCxnSpPr>
          <p:cNvPr id="4" name="Connecteur droit 3">
            <a:extLst>
              <a:ext uri="{FF2B5EF4-FFF2-40B4-BE49-F238E27FC236}">
                <a16:creationId xmlns:a16="http://schemas.microsoft.com/office/drawing/2014/main" id="{8BA08E3B-BC8A-45A2-9696-D23A4C2F8F5B}"/>
              </a:ext>
            </a:extLst>
          </p:cNvPr>
          <p:cNvCxnSpPr>
            <a:cxnSpLocks/>
          </p:cNvCxnSpPr>
          <p:nvPr/>
        </p:nvCxnSpPr>
        <p:spPr>
          <a:xfrm>
            <a:off x="6134263" y="2723130"/>
            <a:ext cx="332290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9932D029-2B99-42AC-B68E-2CDE3A5DB6C8}"/>
              </a:ext>
            </a:extLst>
          </p:cNvPr>
          <p:cNvCxnSpPr>
            <a:cxnSpLocks/>
          </p:cNvCxnSpPr>
          <p:nvPr/>
        </p:nvCxnSpPr>
        <p:spPr>
          <a:xfrm flipV="1">
            <a:off x="6466553" y="2348028"/>
            <a:ext cx="0" cy="649172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50</TotalTime>
  <Words>171</Words>
  <Application>Microsoft Office PowerPoint</Application>
  <PresentationFormat>Grand écran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ésentation PowerPoint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Maria MANSO</cp:lastModifiedBy>
  <cp:revision>68</cp:revision>
  <dcterms:created xsi:type="dcterms:W3CDTF">2019-06-13T12:30:18Z</dcterms:created>
  <dcterms:modified xsi:type="dcterms:W3CDTF">2020-07-02T12:16:01Z</dcterms:modified>
</cp:coreProperties>
</file>